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0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4660"/>
  </p:normalViewPr>
  <p:slideViewPr>
    <p:cSldViewPr snapToGrid="0">
      <p:cViewPr varScale="1">
        <p:scale>
          <a:sx n="122" d="100"/>
          <a:sy n="122" d="100"/>
        </p:scale>
        <p:origin x="-430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958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1780899335566101"/>
          <c:y val="4.0417401528512698E-2"/>
          <c:w val="0.77316695551060299"/>
          <c:h val="0.878821281599060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O$31</c:f>
              <c:strCache>
                <c:ptCount val="1"/>
                <c:pt idx="0">
                  <c:v>Petal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32:$T$36</c:f>
                <c:numCache>
                  <c:formatCode>General</c:formatCode>
                  <c:ptCount val="5"/>
                  <c:pt idx="0">
                    <c:v>5.8186289320038199E-2</c:v>
                  </c:pt>
                  <c:pt idx="1">
                    <c:v>3.4076225689240903E-4</c:v>
                  </c:pt>
                  <c:pt idx="2">
                    <c:v>0.60132678471019696</c:v>
                  </c:pt>
                  <c:pt idx="3">
                    <c:v>6.5764671053784501E-2</c:v>
                  </c:pt>
                  <c:pt idx="4">
                    <c:v>0.94383610112728</c:v>
                  </c:pt>
                </c:numCache>
              </c:numRef>
            </c:plus>
            <c:minus>
              <c:numRef>
                <c:f>Sheet2!$T$32:$T$36</c:f>
                <c:numCache>
                  <c:formatCode>General</c:formatCode>
                  <c:ptCount val="5"/>
                  <c:pt idx="0">
                    <c:v>5.8186289320038199E-2</c:v>
                  </c:pt>
                  <c:pt idx="1">
                    <c:v>3.4076225689240903E-4</c:v>
                  </c:pt>
                  <c:pt idx="2">
                    <c:v>0.60132678471019696</c:v>
                  </c:pt>
                  <c:pt idx="3">
                    <c:v>6.5764671053784501E-2</c:v>
                  </c:pt>
                  <c:pt idx="4">
                    <c:v>0.943836101127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O$32:$O$36</c:f>
              <c:numCache>
                <c:formatCode>General</c:formatCode>
                <c:ptCount val="5"/>
                <c:pt idx="0">
                  <c:v>0.139057406194497</c:v>
                </c:pt>
                <c:pt idx="1">
                  <c:v>4.1777757668173699E-3</c:v>
                </c:pt>
                <c:pt idx="2">
                  <c:v>10.473973449811959</c:v>
                </c:pt>
                <c:pt idx="3">
                  <c:v>0.44209847000095298</c:v>
                </c:pt>
                <c:pt idx="4">
                  <c:v>7.639467878116978</c:v>
                </c:pt>
              </c:numCache>
            </c:numRef>
          </c:val>
        </c:ser>
        <c:ser>
          <c:idx val="1"/>
          <c:order val="1"/>
          <c:tx>
            <c:strRef>
              <c:f>Sheet2!$P$31</c:f>
              <c:strCache>
                <c:ptCount val="1"/>
                <c:pt idx="0">
                  <c:v>Stamen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U$32:$U$36</c:f>
                <c:numCache>
                  <c:formatCode>General</c:formatCode>
                  <c:ptCount val="5"/>
                  <c:pt idx="0">
                    <c:v>9.2387935403072594E-3</c:v>
                  </c:pt>
                  <c:pt idx="1">
                    <c:v>4.0544382337120901E-4</c:v>
                  </c:pt>
                  <c:pt idx="2">
                    <c:v>0.113222551620984</c:v>
                  </c:pt>
                  <c:pt idx="3">
                    <c:v>3.7664156687026197E-2</c:v>
                  </c:pt>
                  <c:pt idx="4">
                    <c:v>8.3339222648543695E-2</c:v>
                  </c:pt>
                </c:numCache>
              </c:numRef>
            </c:plus>
            <c:minus>
              <c:numRef>
                <c:f>Sheet2!$U$32:$U$36</c:f>
                <c:numCache>
                  <c:formatCode>General</c:formatCode>
                  <c:ptCount val="5"/>
                  <c:pt idx="0">
                    <c:v>9.2387935403072594E-3</c:v>
                  </c:pt>
                  <c:pt idx="1">
                    <c:v>4.0544382337120901E-4</c:v>
                  </c:pt>
                  <c:pt idx="2">
                    <c:v>0.113222551620984</c:v>
                  </c:pt>
                  <c:pt idx="3">
                    <c:v>3.7664156687026197E-2</c:v>
                  </c:pt>
                  <c:pt idx="4">
                    <c:v>8.33392226485436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P$32:$P$36</c:f>
              <c:numCache>
                <c:formatCode>General</c:formatCode>
                <c:ptCount val="5"/>
                <c:pt idx="0">
                  <c:v>4.83544591065194E-2</c:v>
                </c:pt>
                <c:pt idx="1">
                  <c:v>4.0704601914283798E-3</c:v>
                </c:pt>
                <c:pt idx="2">
                  <c:v>0.26503992057231102</c:v>
                </c:pt>
                <c:pt idx="3">
                  <c:v>0.22378185105617801</c:v>
                </c:pt>
                <c:pt idx="4">
                  <c:v>0.76260390613184903</c:v>
                </c:pt>
              </c:numCache>
            </c:numRef>
          </c:val>
        </c:ser>
        <c:ser>
          <c:idx val="2"/>
          <c:order val="2"/>
          <c:tx>
            <c:strRef>
              <c:f>Sheet2!$Q$31</c:f>
              <c:strCache>
                <c:ptCount val="1"/>
                <c:pt idx="0">
                  <c:v>Pistil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V$32:$V$36</c:f>
                <c:numCache>
                  <c:formatCode>General</c:formatCode>
                  <c:ptCount val="5"/>
                  <c:pt idx="0">
                    <c:v>1.31893527880758E-2</c:v>
                  </c:pt>
                  <c:pt idx="1">
                    <c:v>3.04957911028616E-4</c:v>
                  </c:pt>
                  <c:pt idx="2">
                    <c:v>0.37043015829450099</c:v>
                  </c:pt>
                  <c:pt idx="3">
                    <c:v>3.0505433891094301E-2</c:v>
                  </c:pt>
                  <c:pt idx="4">
                    <c:v>1.561434297845155</c:v>
                  </c:pt>
                </c:numCache>
              </c:numRef>
            </c:plus>
            <c:minus>
              <c:numRef>
                <c:f>Sheet2!$V$32:$V$36</c:f>
                <c:numCache>
                  <c:formatCode>General</c:formatCode>
                  <c:ptCount val="5"/>
                  <c:pt idx="0">
                    <c:v>1.31893527880758E-2</c:v>
                  </c:pt>
                  <c:pt idx="1">
                    <c:v>3.04957911028616E-4</c:v>
                  </c:pt>
                  <c:pt idx="2">
                    <c:v>0.37043015829450099</c:v>
                  </c:pt>
                  <c:pt idx="3">
                    <c:v>3.0505433891094301E-2</c:v>
                  </c:pt>
                  <c:pt idx="4">
                    <c:v>1.5614342978451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32:$N$36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Q$32:$Q$36</c:f>
              <c:numCache>
                <c:formatCode>General</c:formatCode>
                <c:ptCount val="5"/>
                <c:pt idx="0">
                  <c:v>6.4344500622968995E-2</c:v>
                </c:pt>
                <c:pt idx="1">
                  <c:v>3.0567978815492702E-3</c:v>
                </c:pt>
                <c:pt idx="2">
                  <c:v>2.012520823779246</c:v>
                </c:pt>
                <c:pt idx="3">
                  <c:v>0.100677788732235</c:v>
                </c:pt>
                <c:pt idx="4">
                  <c:v>6.97616395006189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5363968"/>
        <c:axId val="175365504"/>
      </c:barChart>
      <c:catAx>
        <c:axId val="175363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5365504"/>
        <c:crosses val="autoZero"/>
        <c:auto val="1"/>
        <c:lblAlgn val="ctr"/>
        <c:lblOffset val="100"/>
        <c:noMultiLvlLbl val="0"/>
      </c:catAx>
      <c:valAx>
        <c:axId val="175365504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5363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7441537138406302"/>
          <c:y val="6.6709543251537995E-2"/>
          <c:w val="0.18300365291159601"/>
          <c:h val="0.1470174182772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14178011453452"/>
          <c:y val="6.2563297012115895E-2"/>
          <c:w val="0.75987432966845203"/>
          <c:h val="0.814095018425726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O$53</c:f>
              <c:strCache>
                <c:ptCount val="1"/>
                <c:pt idx="0">
                  <c:v>Petal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54:$T$58</c:f>
                <c:numCache>
                  <c:formatCode>General</c:formatCode>
                  <c:ptCount val="5"/>
                  <c:pt idx="0">
                    <c:v>3.0520047407888998E-2</c:v>
                  </c:pt>
                  <c:pt idx="1">
                    <c:v>1.4914023723975099E-3</c:v>
                  </c:pt>
                  <c:pt idx="2">
                    <c:v>1.7542783804095099</c:v>
                  </c:pt>
                  <c:pt idx="3">
                    <c:v>4.2961350746775498E-2</c:v>
                  </c:pt>
                  <c:pt idx="4">
                    <c:v>6.9277868425446476</c:v>
                  </c:pt>
                </c:numCache>
              </c:numRef>
            </c:plus>
            <c:minus>
              <c:numRef>
                <c:f>Sheet2!$T$54:$T$58</c:f>
                <c:numCache>
                  <c:formatCode>General</c:formatCode>
                  <c:ptCount val="5"/>
                  <c:pt idx="0">
                    <c:v>3.0520047407888998E-2</c:v>
                  </c:pt>
                  <c:pt idx="1">
                    <c:v>1.4914023723975099E-3</c:v>
                  </c:pt>
                  <c:pt idx="2">
                    <c:v>1.7542783804095099</c:v>
                  </c:pt>
                  <c:pt idx="3">
                    <c:v>4.2961350746775498E-2</c:v>
                  </c:pt>
                  <c:pt idx="4">
                    <c:v>6.92778684254464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54:$N$58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O$54:$O$58</c:f>
              <c:numCache>
                <c:formatCode>General</c:formatCode>
                <c:ptCount val="5"/>
                <c:pt idx="0">
                  <c:v>0.14234340473465901</c:v>
                </c:pt>
                <c:pt idx="1">
                  <c:v>4.0978163557256198E-3</c:v>
                </c:pt>
                <c:pt idx="2">
                  <c:v>6.3260702184514139</c:v>
                </c:pt>
                <c:pt idx="3">
                  <c:v>0.20337277256553901</c:v>
                </c:pt>
                <c:pt idx="4">
                  <c:v>20.53294544347666</c:v>
                </c:pt>
              </c:numCache>
            </c:numRef>
          </c:val>
        </c:ser>
        <c:ser>
          <c:idx val="1"/>
          <c:order val="1"/>
          <c:tx>
            <c:strRef>
              <c:f>Sheet2!$P$53</c:f>
              <c:strCache>
                <c:ptCount val="1"/>
                <c:pt idx="0">
                  <c:v>Stamen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U$54:$U$58</c:f>
                <c:numCache>
                  <c:formatCode>General</c:formatCode>
                  <c:ptCount val="5"/>
                  <c:pt idx="0">
                    <c:v>7.8283709764346201E-3</c:v>
                  </c:pt>
                  <c:pt idx="1">
                    <c:v>4.36801886241179E-3</c:v>
                  </c:pt>
                  <c:pt idx="2">
                    <c:v>2.2991187059883799E-2</c:v>
                  </c:pt>
                  <c:pt idx="3">
                    <c:v>3.4969666572949899E-2</c:v>
                  </c:pt>
                  <c:pt idx="4">
                    <c:v>7.7690741082035095E-2</c:v>
                  </c:pt>
                </c:numCache>
              </c:numRef>
            </c:plus>
            <c:minus>
              <c:numRef>
                <c:f>Sheet2!$U$54:$U$58</c:f>
                <c:numCache>
                  <c:formatCode>General</c:formatCode>
                  <c:ptCount val="5"/>
                  <c:pt idx="0">
                    <c:v>7.8283709764346201E-3</c:v>
                  </c:pt>
                  <c:pt idx="1">
                    <c:v>4.36801886241179E-3</c:v>
                  </c:pt>
                  <c:pt idx="2">
                    <c:v>2.2991187059883799E-2</c:v>
                  </c:pt>
                  <c:pt idx="3">
                    <c:v>3.4969666572949899E-2</c:v>
                  </c:pt>
                  <c:pt idx="4">
                    <c:v>7.76907410820350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54:$N$58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P$54:$P$58</c:f>
              <c:numCache>
                <c:formatCode>General</c:formatCode>
                <c:ptCount val="5"/>
                <c:pt idx="0">
                  <c:v>3.9197693566404998E-2</c:v>
                </c:pt>
                <c:pt idx="1">
                  <c:v>8.4008385182614206E-3</c:v>
                </c:pt>
                <c:pt idx="2">
                  <c:v>0.13873776016245201</c:v>
                </c:pt>
                <c:pt idx="3">
                  <c:v>0.113592448615483</c:v>
                </c:pt>
                <c:pt idx="4">
                  <c:v>0.81243161401616504</c:v>
                </c:pt>
              </c:numCache>
            </c:numRef>
          </c:val>
        </c:ser>
        <c:ser>
          <c:idx val="2"/>
          <c:order val="2"/>
          <c:tx>
            <c:strRef>
              <c:f>Sheet2!$Q$53</c:f>
              <c:strCache>
                <c:ptCount val="1"/>
                <c:pt idx="0">
                  <c:v>Pistil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V$54:$V$58</c:f>
                <c:numCache>
                  <c:formatCode>General</c:formatCode>
                  <c:ptCount val="5"/>
                  <c:pt idx="0">
                    <c:v>1.02752657913464E-2</c:v>
                  </c:pt>
                  <c:pt idx="1">
                    <c:v>6.6456844101847102E-4</c:v>
                  </c:pt>
                  <c:pt idx="2">
                    <c:v>0.557049565072539</c:v>
                  </c:pt>
                  <c:pt idx="3">
                    <c:v>1.9035070733152699E-2</c:v>
                  </c:pt>
                  <c:pt idx="4">
                    <c:v>0.52117063400085095</c:v>
                  </c:pt>
                </c:numCache>
              </c:numRef>
            </c:plus>
            <c:minus>
              <c:numRef>
                <c:f>Sheet2!$V$54:$V$58</c:f>
                <c:numCache>
                  <c:formatCode>General</c:formatCode>
                  <c:ptCount val="5"/>
                  <c:pt idx="0">
                    <c:v>1.02752657913464E-2</c:v>
                  </c:pt>
                  <c:pt idx="1">
                    <c:v>6.6456844101847102E-4</c:v>
                  </c:pt>
                  <c:pt idx="2">
                    <c:v>0.557049565072539</c:v>
                  </c:pt>
                  <c:pt idx="3">
                    <c:v>1.9035070733152699E-2</c:v>
                  </c:pt>
                  <c:pt idx="4">
                    <c:v>0.521170634000850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N$54:$N$58</c:f>
              <c:strCache>
                <c:ptCount val="5"/>
                <c:pt idx="0">
                  <c:v>SrPK</c:v>
                </c:pt>
                <c:pt idx="1">
                  <c:v>SrPEPtase</c:v>
                </c:pt>
                <c:pt idx="2">
                  <c:v>SrPEPC</c:v>
                </c:pt>
                <c:pt idx="3">
                  <c:v>SrPEPCK</c:v>
                </c:pt>
                <c:pt idx="4">
                  <c:v>SrAOX</c:v>
                </c:pt>
              </c:strCache>
            </c:strRef>
          </c:cat>
          <c:val>
            <c:numRef>
              <c:f>Sheet2!$Q$54:$Q$58</c:f>
              <c:numCache>
                <c:formatCode>General</c:formatCode>
                <c:ptCount val="5"/>
                <c:pt idx="0">
                  <c:v>9.6475434915639494E-2</c:v>
                </c:pt>
                <c:pt idx="1">
                  <c:v>4.10182323213401E-3</c:v>
                </c:pt>
                <c:pt idx="2">
                  <c:v>5.7320447175285878</c:v>
                </c:pt>
                <c:pt idx="3">
                  <c:v>6.8056017633909102E-2</c:v>
                </c:pt>
                <c:pt idx="4">
                  <c:v>22.3918044575991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023424"/>
        <c:axId val="176024960"/>
      </c:barChart>
      <c:catAx>
        <c:axId val="176023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6024960"/>
        <c:crosses val="autoZero"/>
        <c:auto val="1"/>
        <c:lblAlgn val="ctr"/>
        <c:lblOffset val="100"/>
        <c:noMultiLvlLbl val="0"/>
      </c:catAx>
      <c:valAx>
        <c:axId val="176024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6023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7464979187652999"/>
          <c:y val="8.8621782125719098E-2"/>
          <c:w val="0.18300376333000801"/>
          <c:h val="0.150691627561706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5" y="2"/>
            <a:ext cx="3076363" cy="513508"/>
          </a:xfrm>
          <a:prstGeom prst="rect">
            <a:avLst/>
          </a:prstGeom>
        </p:spPr>
        <p:txBody>
          <a:bodyPr vert="horz" lIns="94768" tIns="47384" rIns="94768" bIns="47384" rtlCol="0"/>
          <a:lstStyle>
            <a:lvl1pPr algn="r">
              <a:defRPr sz="1200"/>
            </a:lvl1pPr>
          </a:lstStyle>
          <a:p>
            <a:fld id="{9D67A089-3EC3-4620-BEEE-B1748E8A2621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8" tIns="47384" rIns="94768" bIns="473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4768" tIns="47384" rIns="94768" bIns="4738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5" y="9721108"/>
            <a:ext cx="3076363" cy="513507"/>
          </a:xfrm>
          <a:prstGeom prst="rect">
            <a:avLst/>
          </a:prstGeom>
        </p:spPr>
        <p:txBody>
          <a:bodyPr vert="horz" lIns="94768" tIns="47384" rIns="94768" bIns="47384" rtlCol="0" anchor="b"/>
          <a:lstStyle>
            <a:lvl1pPr algn="r">
              <a:defRPr sz="1200"/>
            </a:lvl1pPr>
          </a:lstStyle>
          <a:p>
            <a:fld id="{8B992F4F-6D07-4AA1-BEBD-0C3C3AE2D6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05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10" indent="0" algn="ctr">
              <a:buNone/>
              <a:defRPr sz="1500"/>
            </a:lvl2pPr>
            <a:lvl3pPr marL="685822" indent="0" algn="ctr">
              <a:buNone/>
              <a:defRPr sz="1350"/>
            </a:lvl3pPr>
            <a:lvl4pPr marL="1028732" indent="0" algn="ctr">
              <a:buNone/>
              <a:defRPr sz="1200"/>
            </a:lvl4pPr>
            <a:lvl5pPr marL="1371643" indent="0" algn="ctr">
              <a:buNone/>
              <a:defRPr sz="1200"/>
            </a:lvl5pPr>
            <a:lvl6pPr marL="1714553" indent="0" algn="ctr">
              <a:buNone/>
              <a:defRPr sz="1200"/>
            </a:lvl6pPr>
            <a:lvl7pPr marL="2057465" indent="0" algn="ctr">
              <a:buNone/>
              <a:defRPr sz="1200"/>
            </a:lvl7pPr>
            <a:lvl8pPr marL="2400375" indent="0" algn="ctr">
              <a:buNone/>
              <a:defRPr sz="1200"/>
            </a:lvl8pPr>
            <a:lvl9pPr marL="2743285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92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8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6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6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0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056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5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1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2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6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83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5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10" indent="0">
              <a:buNone/>
              <a:defRPr sz="1500" b="1"/>
            </a:lvl2pPr>
            <a:lvl3pPr marL="685822" indent="0">
              <a:buNone/>
              <a:defRPr sz="1350" b="1"/>
            </a:lvl3pPr>
            <a:lvl4pPr marL="1028732" indent="0">
              <a:buNone/>
              <a:defRPr sz="1200" b="1"/>
            </a:lvl4pPr>
            <a:lvl5pPr marL="1371643" indent="0">
              <a:buNone/>
              <a:defRPr sz="1200" b="1"/>
            </a:lvl5pPr>
            <a:lvl6pPr marL="1714553" indent="0">
              <a:buNone/>
              <a:defRPr sz="1200" b="1"/>
            </a:lvl6pPr>
            <a:lvl7pPr marL="2057465" indent="0">
              <a:buNone/>
              <a:defRPr sz="1200" b="1"/>
            </a:lvl7pPr>
            <a:lvl8pPr marL="2400375" indent="0">
              <a:buNone/>
              <a:defRPr sz="1200" b="1"/>
            </a:lvl8pPr>
            <a:lvl9pPr marL="274328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447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34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9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583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0" indent="0">
              <a:buNone/>
              <a:defRPr sz="2100"/>
            </a:lvl2pPr>
            <a:lvl3pPr marL="685822" indent="0">
              <a:buNone/>
              <a:defRPr sz="1800"/>
            </a:lvl3pPr>
            <a:lvl4pPr marL="1028732" indent="0">
              <a:buNone/>
              <a:defRPr sz="1500"/>
            </a:lvl4pPr>
            <a:lvl5pPr marL="1371643" indent="0">
              <a:buNone/>
              <a:defRPr sz="1500"/>
            </a:lvl5pPr>
            <a:lvl6pPr marL="1714553" indent="0">
              <a:buNone/>
              <a:defRPr sz="1500"/>
            </a:lvl6pPr>
            <a:lvl7pPr marL="2057465" indent="0">
              <a:buNone/>
              <a:defRPr sz="1500"/>
            </a:lvl7pPr>
            <a:lvl8pPr marL="2400375" indent="0">
              <a:buNone/>
              <a:defRPr sz="1500"/>
            </a:lvl8pPr>
            <a:lvl9pPr marL="2743285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10" indent="0">
              <a:buNone/>
              <a:defRPr sz="1050"/>
            </a:lvl2pPr>
            <a:lvl3pPr marL="685822" indent="0">
              <a:buNone/>
              <a:defRPr sz="900"/>
            </a:lvl3pPr>
            <a:lvl4pPr marL="1028732" indent="0">
              <a:buNone/>
              <a:defRPr sz="750"/>
            </a:lvl4pPr>
            <a:lvl5pPr marL="1371643" indent="0">
              <a:buNone/>
              <a:defRPr sz="750"/>
            </a:lvl5pPr>
            <a:lvl6pPr marL="1714553" indent="0">
              <a:buNone/>
              <a:defRPr sz="750"/>
            </a:lvl6pPr>
            <a:lvl7pPr marL="2057465" indent="0">
              <a:buNone/>
              <a:defRPr sz="750"/>
            </a:lvl7pPr>
            <a:lvl8pPr marL="2400375" indent="0">
              <a:buNone/>
              <a:defRPr sz="750"/>
            </a:lvl8pPr>
            <a:lvl9pPr marL="2743285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257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2D3-1E85-4B8F-B11B-1D94F4B19A4E}" type="datetimeFigureOut">
              <a:rPr lang="en-US" smtClean="0"/>
              <a:t>11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2464E-9D9F-48DC-B464-E125B50100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88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2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6" indent="-171456" algn="l" defTabSz="68582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6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77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8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8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00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919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3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41" indent="-171456" algn="l" defTabSz="68582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10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2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32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4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53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6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7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85" algn="l" defTabSz="68582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051796" y="460238"/>
            <a:ext cx="4369277" cy="6871124"/>
            <a:chOff x="655593" y="577469"/>
            <a:chExt cx="4369277" cy="6871124"/>
          </a:xfrm>
        </p:grpSpPr>
        <p:sp>
          <p:nvSpPr>
            <p:cNvPr id="30" name="テキスト ボックス 29"/>
            <p:cNvSpPr txBox="1"/>
            <p:nvPr/>
          </p:nvSpPr>
          <p:spPr>
            <a:xfrm>
              <a:off x="655593" y="577469"/>
              <a:ext cx="4399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655593" y="4168297"/>
              <a:ext cx="4399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sz="2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14476493"/>
                </p:ext>
              </p:extLst>
            </p:nvPr>
          </p:nvGraphicFramePr>
          <p:xfrm>
            <a:off x="1039465" y="869293"/>
            <a:ext cx="3916393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5" name="テキスト ボックス 26"/>
            <p:cNvSpPr txBox="1"/>
            <p:nvPr/>
          </p:nvSpPr>
          <p:spPr>
            <a:xfrm>
              <a:off x="1936068" y="3690029"/>
              <a:ext cx="2989629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rPK      SrPEPtase  SrPEPC   SrPEPCK    SrAOX</a:t>
              </a:r>
              <a:endParaRPr kumimoji="1" lang="ja-JP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Chart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17586476"/>
                </p:ext>
              </p:extLst>
            </p:nvPr>
          </p:nvGraphicFramePr>
          <p:xfrm>
            <a:off x="1035171" y="4431073"/>
            <a:ext cx="3989699" cy="3017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9" name="テキスト ボックス 26"/>
            <p:cNvSpPr txBox="1"/>
            <p:nvPr/>
          </p:nvSpPr>
          <p:spPr>
            <a:xfrm>
              <a:off x="1929689" y="7135829"/>
              <a:ext cx="3065020" cy="230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rPK      SrPEPtase  SrPEPC   SrPEPCK    SrAOX</a:t>
              </a:r>
              <a:endParaRPr kumimoji="1" lang="ja-JP" alt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"/>
            <p:cNvSpPr txBox="1"/>
            <p:nvPr/>
          </p:nvSpPr>
          <p:spPr>
            <a:xfrm rot="16200000">
              <a:off x="485821" y="2065812"/>
              <a:ext cx="190260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ratio to </a:t>
              </a:r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F1</a:t>
              </a:r>
              <a:r>
                <a:rPr kumimoji="1" lang="en-US" altLang="ja-JP" sz="1200" i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kumimoji="1" lang="ja-JP" altLang="en-US" sz="1200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"/>
            <p:cNvSpPr txBox="1"/>
            <p:nvPr/>
          </p:nvSpPr>
          <p:spPr>
            <a:xfrm rot="16200000">
              <a:off x="474931" y="5609311"/>
              <a:ext cx="190260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xpression ratio to </a:t>
              </a:r>
              <a:r>
                <a:rPr kumimoji="1" lang="en-US" altLang="ja-JP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F1</a:t>
              </a:r>
              <a:r>
                <a:rPr kumimoji="1" lang="en-US" altLang="ja-JP" sz="1200" i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kumimoji="1" lang="ja-JP" altLang="en-US" sz="1200" i="1" dirty="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</p:grpSp>
      <p:sp>
        <p:nvSpPr>
          <p:cNvPr id="14" name="正方形/長方形 13"/>
          <p:cNvSpPr/>
          <p:nvPr/>
        </p:nvSpPr>
        <p:spPr>
          <a:xfrm>
            <a:off x="983620" y="7490116"/>
            <a:ext cx="5487518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Figure 2. </a:t>
            </a:r>
            <a:r>
              <a:rPr lang="en-US" altLang="ja-JP" sz="1050" dirty="0">
                <a:latin typeface="Arial"/>
                <a:cs typeface="Arial"/>
              </a:rPr>
              <a:t>qRT-PCR analyses for </a:t>
            </a:r>
            <a:r>
              <a:rPr lang="en-US" altLang="ja-JP" sz="1050" i="1" dirty="0">
                <a:latin typeface="Arial"/>
                <a:cs typeface="Arial"/>
              </a:rPr>
              <a:t>SrPK</a:t>
            </a:r>
            <a:r>
              <a:rPr lang="en-US" altLang="ja-JP" sz="1050" dirty="0">
                <a:latin typeface="Arial"/>
                <a:cs typeface="Arial"/>
              </a:rPr>
              <a:t>, </a:t>
            </a:r>
            <a:r>
              <a:rPr lang="en-US" altLang="ja-JP" sz="1050" i="1" dirty="0" smtClean="0">
                <a:latin typeface="Arial"/>
                <a:cs typeface="Arial"/>
              </a:rPr>
              <a:t>SrPEPtase</a:t>
            </a:r>
            <a:r>
              <a:rPr lang="en-US" altLang="ja-JP" sz="1050" dirty="0" smtClean="0">
                <a:latin typeface="Arial"/>
                <a:cs typeface="Arial"/>
              </a:rPr>
              <a:t>, </a:t>
            </a:r>
            <a:r>
              <a:rPr lang="en-US" altLang="ja-JP" sz="1050" i="1" dirty="0">
                <a:latin typeface="Arial"/>
                <a:cs typeface="Arial"/>
              </a:rPr>
              <a:t>SrPEPC</a:t>
            </a:r>
            <a:r>
              <a:rPr lang="en-US" altLang="ja-JP" sz="1050" dirty="0">
                <a:latin typeface="Arial"/>
                <a:cs typeface="Arial"/>
              </a:rPr>
              <a:t>, </a:t>
            </a:r>
            <a:r>
              <a:rPr lang="en-US" altLang="ja-JP" sz="1050" i="1" dirty="0">
                <a:latin typeface="Arial"/>
                <a:cs typeface="Arial"/>
              </a:rPr>
              <a:t>SrPEPCK</a:t>
            </a:r>
            <a:r>
              <a:rPr lang="en-US" altLang="ja-JP" sz="1050" dirty="0">
                <a:latin typeface="Arial"/>
                <a:cs typeface="Arial"/>
              </a:rPr>
              <a:t>, and </a:t>
            </a:r>
            <a:r>
              <a:rPr lang="en-US" altLang="ja-JP" sz="1050" i="1" dirty="0">
                <a:latin typeface="Arial"/>
                <a:cs typeface="Arial"/>
              </a:rPr>
              <a:t>SrAOX</a:t>
            </a:r>
            <a:r>
              <a:rPr lang="en-US" altLang="ja-JP" sz="1050" dirty="0">
                <a:latin typeface="Arial"/>
                <a:cs typeface="Arial"/>
              </a:rPr>
              <a:t> transcripts in various tissues of thermogenic stage of </a:t>
            </a:r>
            <a:r>
              <a:rPr lang="en-US" altLang="ja-JP" sz="1050" i="1" dirty="0">
                <a:latin typeface="Arial"/>
                <a:cs typeface="Arial"/>
              </a:rPr>
              <a:t>S. renifolius</a:t>
            </a:r>
            <a:r>
              <a:rPr lang="en-US" altLang="ja-JP" sz="1050" dirty="0">
                <a:latin typeface="Arial"/>
                <a:cs typeface="Arial"/>
              </a:rPr>
              <a:t>. Samples for the petal, stamen, and pistil were collected from two different plants (a &amp; b) at Fujine, Iwate prefecture, Japan on  April 3, 2012. </a:t>
            </a:r>
            <a:r>
              <a:rPr lang="en-US" altLang="ja-JP" sz="1050" i="1" dirty="0">
                <a:latin typeface="Arial"/>
                <a:cs typeface="Arial"/>
              </a:rPr>
              <a:t>EF1α</a:t>
            </a:r>
            <a:r>
              <a:rPr lang="en-US" altLang="ja-JP" sz="1050" dirty="0">
                <a:latin typeface="Arial"/>
                <a:cs typeface="Arial"/>
              </a:rPr>
              <a:t> transcripts were used as a normalization control. Experiments were performed in triplicate for each sample. Data are expressed as the mean ± standard deviation</a:t>
            </a:r>
            <a:r>
              <a:rPr lang="en-US" altLang="ja-JP" sz="1050" dirty="0" smtClean="0">
                <a:latin typeface="Arial"/>
                <a:cs typeface="Arial"/>
              </a:rPr>
              <a:t>.</a:t>
            </a:r>
            <a:r>
              <a:rPr lang="en-US" altLang="ja-JP" sz="1050" dirty="0">
                <a:latin typeface="Arial"/>
                <a:cs typeface="Arial"/>
              </a:rPr>
              <a:t> Values with different letters in the graph indicate that they are statistically significantly different (</a:t>
            </a:r>
            <a:r>
              <a:rPr lang="en-US" altLang="ja-JP" sz="1050" i="1" dirty="0">
                <a:latin typeface="Arial"/>
                <a:cs typeface="Arial"/>
              </a:rPr>
              <a:t>n</a:t>
            </a:r>
            <a:r>
              <a:rPr lang="en-US" altLang="ja-JP" sz="1050" dirty="0">
                <a:latin typeface="Arial"/>
                <a:cs typeface="Arial"/>
              </a:rPr>
              <a:t> = 3; </a:t>
            </a:r>
            <a:r>
              <a:rPr lang="en-US" altLang="ja-JP" sz="1050" i="1" dirty="0">
                <a:latin typeface="Arial"/>
                <a:cs typeface="Arial"/>
              </a:rPr>
              <a:t>P</a:t>
            </a:r>
            <a:r>
              <a:rPr lang="en-US" altLang="ja-JP" sz="1050" dirty="0">
                <a:latin typeface="Arial"/>
                <a:cs typeface="Arial"/>
              </a:rPr>
              <a:t>&lt;0.05</a:t>
            </a:r>
            <a:r>
              <a:rPr lang="en-US" altLang="ja-JP" sz="1050" dirty="0" smtClean="0">
                <a:latin typeface="Arial"/>
                <a:cs typeface="Arial"/>
              </a:rPr>
              <a:t>).</a:t>
            </a:r>
            <a:endParaRPr lang="ja-JP" altLang="ja-JP" sz="1050" dirty="0">
              <a:latin typeface="Arial"/>
              <a:cs typeface="Arial"/>
            </a:endParaRPr>
          </a:p>
        </p:txBody>
      </p:sp>
      <p:sp>
        <p:nvSpPr>
          <p:cNvPr id="16" name="TextBox 183"/>
          <p:cNvSpPr txBox="1"/>
          <p:nvPr/>
        </p:nvSpPr>
        <p:spPr>
          <a:xfrm>
            <a:off x="2355804" y="334136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85"/>
          <p:cNvSpPr txBox="1"/>
          <p:nvPr/>
        </p:nvSpPr>
        <p:spPr>
          <a:xfrm>
            <a:off x="2478415" y="335474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86"/>
          <p:cNvSpPr txBox="1"/>
          <p:nvPr/>
        </p:nvSpPr>
        <p:spPr>
          <a:xfrm>
            <a:off x="2582092" y="33617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83"/>
          <p:cNvSpPr txBox="1"/>
          <p:nvPr/>
        </p:nvSpPr>
        <p:spPr>
          <a:xfrm>
            <a:off x="2943981" y="33604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85"/>
          <p:cNvSpPr txBox="1"/>
          <p:nvPr/>
        </p:nvSpPr>
        <p:spPr>
          <a:xfrm>
            <a:off x="3092840" y="336665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86"/>
          <p:cNvSpPr txBox="1"/>
          <p:nvPr/>
        </p:nvSpPr>
        <p:spPr>
          <a:xfrm>
            <a:off x="3241699" y="337602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83"/>
          <p:cNvSpPr txBox="1"/>
          <p:nvPr/>
        </p:nvSpPr>
        <p:spPr>
          <a:xfrm>
            <a:off x="3553588" y="236980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85"/>
          <p:cNvSpPr txBox="1"/>
          <p:nvPr/>
        </p:nvSpPr>
        <p:spPr>
          <a:xfrm>
            <a:off x="3692923" y="333088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86"/>
          <p:cNvSpPr txBox="1"/>
          <p:nvPr/>
        </p:nvSpPr>
        <p:spPr>
          <a:xfrm>
            <a:off x="3817972" y="315456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183"/>
          <p:cNvSpPr txBox="1"/>
          <p:nvPr/>
        </p:nvSpPr>
        <p:spPr>
          <a:xfrm>
            <a:off x="4156042" y="332945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85"/>
          <p:cNvSpPr txBox="1"/>
          <p:nvPr/>
        </p:nvSpPr>
        <p:spPr>
          <a:xfrm>
            <a:off x="4297758" y="333569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86"/>
          <p:cNvSpPr txBox="1"/>
          <p:nvPr/>
        </p:nvSpPr>
        <p:spPr>
          <a:xfrm>
            <a:off x="4429950" y="3349826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83"/>
          <p:cNvSpPr txBox="1"/>
          <p:nvPr/>
        </p:nvSpPr>
        <p:spPr>
          <a:xfrm>
            <a:off x="4763261" y="259840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85"/>
          <p:cNvSpPr txBox="1"/>
          <p:nvPr/>
        </p:nvSpPr>
        <p:spPr>
          <a:xfrm>
            <a:off x="4904977" y="329513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86"/>
          <p:cNvSpPr txBox="1"/>
          <p:nvPr/>
        </p:nvSpPr>
        <p:spPr>
          <a:xfrm>
            <a:off x="5034788" y="2609254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83"/>
          <p:cNvSpPr txBox="1"/>
          <p:nvPr/>
        </p:nvSpPr>
        <p:spPr>
          <a:xfrm>
            <a:off x="4766278" y="452528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85"/>
          <p:cNvSpPr txBox="1"/>
          <p:nvPr/>
        </p:nvSpPr>
        <p:spPr>
          <a:xfrm>
            <a:off x="4907994" y="671139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86"/>
          <p:cNvSpPr txBox="1"/>
          <p:nvPr/>
        </p:nvSpPr>
        <p:spPr>
          <a:xfrm>
            <a:off x="5037805" y="491640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83"/>
          <p:cNvSpPr txBox="1"/>
          <p:nvPr/>
        </p:nvSpPr>
        <p:spPr>
          <a:xfrm>
            <a:off x="4168114" y="675920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85"/>
          <p:cNvSpPr txBox="1"/>
          <p:nvPr/>
        </p:nvSpPr>
        <p:spPr>
          <a:xfrm>
            <a:off x="4309830" y="676544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86"/>
          <p:cNvSpPr txBox="1"/>
          <p:nvPr/>
        </p:nvSpPr>
        <p:spPr>
          <a:xfrm>
            <a:off x="4442022" y="677958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83"/>
          <p:cNvSpPr txBox="1"/>
          <p:nvPr/>
        </p:nvSpPr>
        <p:spPr>
          <a:xfrm>
            <a:off x="3556606" y="611192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85"/>
          <p:cNvSpPr txBox="1"/>
          <p:nvPr/>
        </p:nvSpPr>
        <p:spPr>
          <a:xfrm>
            <a:off x="3686887" y="6760639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86"/>
          <p:cNvSpPr txBox="1"/>
          <p:nvPr/>
        </p:nvSpPr>
        <p:spPr>
          <a:xfrm>
            <a:off x="3825517" y="626743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83"/>
          <p:cNvSpPr txBox="1"/>
          <p:nvPr/>
        </p:nvSpPr>
        <p:spPr>
          <a:xfrm>
            <a:off x="2946999" y="67831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85"/>
          <p:cNvSpPr txBox="1"/>
          <p:nvPr/>
        </p:nvSpPr>
        <p:spPr>
          <a:xfrm>
            <a:off x="3095858" y="67831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86"/>
          <p:cNvSpPr txBox="1"/>
          <p:nvPr/>
        </p:nvSpPr>
        <p:spPr>
          <a:xfrm>
            <a:off x="3244717" y="6783143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83"/>
          <p:cNvSpPr txBox="1"/>
          <p:nvPr/>
        </p:nvSpPr>
        <p:spPr>
          <a:xfrm>
            <a:off x="2361542" y="67906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85"/>
          <p:cNvSpPr txBox="1"/>
          <p:nvPr/>
        </p:nvSpPr>
        <p:spPr>
          <a:xfrm>
            <a:off x="2492293" y="67906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86"/>
          <p:cNvSpPr txBox="1"/>
          <p:nvPr/>
        </p:nvSpPr>
        <p:spPr>
          <a:xfrm>
            <a:off x="2659260" y="67906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6725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8</TotalTime>
  <Words>163</Words>
  <Application>Microsoft Office PowerPoint</Application>
  <PresentationFormat>画面に合わせる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Theme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viewer</dc:creator>
  <cp:lastModifiedBy>Kikukatsu Ito</cp:lastModifiedBy>
  <cp:revision>374</cp:revision>
  <cp:lastPrinted>2016-09-21T04:13:31Z</cp:lastPrinted>
  <dcterms:created xsi:type="dcterms:W3CDTF">2016-01-08T01:07:56Z</dcterms:created>
  <dcterms:modified xsi:type="dcterms:W3CDTF">2016-11-01T02:43:18Z</dcterms:modified>
</cp:coreProperties>
</file>